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3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88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D161EA-BBA6-41EB-4568-A813B60953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B5E422-DCAD-A164-E9A7-0AB757122D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3C7C4-E5AB-C195-0273-41313AC8B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9AFEE5-5D4E-37BC-5B6C-B52C8326D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2C412E-C34E-C8D9-CB29-7747FF8CD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7104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AD498-0AF4-7326-21BA-A0EC11E80F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923241-5BC2-10C4-D451-A19EA756C4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B6B2C4-C098-137F-1BF9-AF53FB26C6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6650F-197C-4B48-1365-B5EAEFE16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6481FB-4AD7-BC42-7FEC-694751D3F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1551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2700D5-4835-84AF-B244-950A65FEE8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6449E4-0B19-2544-40D9-F2A699D18D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47B0C6-B3A2-B3CB-6389-7ECADA906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9A59CC-A323-3905-C3D0-2D156CB3F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370138-6775-40D5-89F3-BC5848143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5004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B5A08D-1E07-7415-2EC2-76BC02CCB8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477C86-1ED0-A462-7CAB-729E4707E5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178225-35A8-2C49-723F-CABE2F671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3D68B7-6923-2F8E-7EED-4CDDB06A4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F03318-9B7B-A238-5F54-1027207B3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2265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7A33B-A10C-D019-2841-F5CF246B0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7E0C75-1637-293C-70C1-B5EA26D85C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07BC43-8306-F6DF-3AE2-01A704A6B4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A6F364-CD3C-2158-E38A-182CA5DE6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5B1E3A-9C35-350D-2EBB-0F8F40C64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7450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779A75-3720-B77A-C339-78E6D7DA07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310102-DA36-606F-E299-A76012A9A4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2BD955-8795-FB94-B3B2-6881BF608B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5E96FB-94BF-DCDF-4A3C-65A4446AE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AE3B37-404F-526A-69A8-981E71458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01415A-527C-CFEC-4F2C-6E0AF7C2E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8049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30F1F8-D03C-A434-CE1E-7AF23C0506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6C7F17-F837-1AF5-2430-214D63D1B8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E982CB-7F53-C8AA-8165-38710B5661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F4D179-B778-DA6D-A651-B57A5ABF1B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893C8B-2C68-5D54-D059-E4FCB3ECD5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C70DB7-6CDE-95B7-3AE1-188C94589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EE3B6C-D6C3-7B28-A855-0B963BECE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D5873A-774E-C913-8EE5-8E9741F83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6504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9A0BD0-6F7E-F701-07C0-4A853FFF20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DE0B07-A898-F2D9-EC14-EA1FAB6AA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934E92-3286-D181-7D18-CDC6EAE2C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2C9E6F-332B-7871-01ED-09C75687F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2661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8AEC4E-E911-23A6-0D1D-BA02474BF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43F833-2BC4-6160-BC90-6E1AFF5E0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3D9F83-B41B-1EAE-A576-4AE60DE175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1781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951E6E-5A10-D01E-0863-F52CFA2125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ECA7C3-ED67-BAC1-A79D-8B9449705F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9FDF77-3F13-B931-AA53-11F2E3D4A6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89FFD2-5A94-6DAE-6D80-73326FFEF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C63F1B-54A9-06A8-E925-87C0AC4B6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953DCF-3978-0B4A-D527-3D7E8F4CA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5620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A00F6-0D09-2161-9F01-E80091D80F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8BC986-AA97-0609-84F1-B6D6959DAF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49B2BC-7919-2428-4F55-982B388F03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225252-29E0-6FA0-D9ED-548D0A15E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84EE81-B8A1-1C5F-CF88-485BE0287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808334-83C4-0C73-13C4-05ECE0227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5446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AA52EBD-7603-D645-F84D-D52B6F4C24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068272-C56B-7E0E-CA8C-3B826C7F76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02CF9D-DEFC-606E-E00B-3E587BF432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A275656-5FB4-4820-9DFC-5E27445723F3}" type="datetimeFigureOut">
              <a:rPr lang="zh-CN" altLang="en-US" smtClean="0"/>
              <a:t>2025/10/25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47D2FA-1818-2CBC-4FAA-4151FA18CD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F4B7D1-80BC-BAC6-3263-E0EE1FB44F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DBF59F-A295-401B-8ECE-A5E2E1B49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7903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A404AE3-3963-45A6-9046-5CF838221943}"/>
              </a:ext>
            </a:extLst>
          </p:cNvPr>
          <p:cNvSpPr txBox="1"/>
          <p:nvPr/>
        </p:nvSpPr>
        <p:spPr>
          <a:xfrm>
            <a:off x="3859437" y="590141"/>
            <a:ext cx="6696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low Cytometry gating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trategy for CD8</a:t>
            </a:r>
            <a:r>
              <a:rPr lang="en-US" altLang="zh-CN" sz="1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D11c</a:t>
            </a:r>
            <a:r>
              <a:rPr lang="en-US" altLang="zh-CN" sz="1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DCs.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2DEA7D5D-A1AD-4DEF-B105-D92BA3ACC24F}"/>
              </a:ext>
            </a:extLst>
          </p:cNvPr>
          <p:cNvGrpSpPr/>
          <p:nvPr/>
        </p:nvGrpSpPr>
        <p:grpSpPr>
          <a:xfrm>
            <a:off x="2243471" y="1178180"/>
            <a:ext cx="7519274" cy="5211988"/>
            <a:chOff x="834177" y="2024289"/>
            <a:chExt cx="3728633" cy="2572271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8825731-123F-4595-9FA9-D2D733641D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33986" y="2024289"/>
              <a:ext cx="914400" cy="9144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828A998-5391-4F66-8257-1814D89858B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95716" y="2024635"/>
              <a:ext cx="914400" cy="9144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011C58B-7176-49A9-84F3-6290208166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48410" y="2038350"/>
              <a:ext cx="914400" cy="9144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30F4ADC-3322-4AE4-AC23-0CAE5449241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98058" y="3461842"/>
              <a:ext cx="914400" cy="9144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CFE91F9-2E0F-46D6-998B-64D9EB93719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48410" y="3421729"/>
              <a:ext cx="914400" cy="914400"/>
            </a:xfrm>
            <a:prstGeom prst="rect">
              <a:avLst/>
            </a:prstGeom>
          </p:spPr>
        </p:pic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ED18B04B-CF23-4317-94D4-53877DA87A4F}"/>
                </a:ext>
              </a:extLst>
            </p:cNvPr>
            <p:cNvCxnSpPr>
              <a:cxnSpLocks/>
            </p:cNvCxnSpPr>
            <p:nvPr/>
          </p:nvCxnSpPr>
          <p:spPr>
            <a:xfrm>
              <a:off x="1822604" y="2762280"/>
              <a:ext cx="32784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788FAC2D-7BBD-4F65-9A74-4B3685E7A97C}"/>
                </a:ext>
              </a:extLst>
            </p:cNvPr>
            <p:cNvCxnSpPr>
              <a:cxnSpLocks/>
            </p:cNvCxnSpPr>
            <p:nvPr/>
          </p:nvCxnSpPr>
          <p:spPr>
            <a:xfrm>
              <a:off x="3174444" y="2345557"/>
              <a:ext cx="31643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27037D86-B841-4544-BE7B-CB2B3E6B69F2}"/>
                </a:ext>
              </a:extLst>
            </p:cNvPr>
            <p:cNvCxnSpPr>
              <a:cxnSpLocks/>
            </p:cNvCxnSpPr>
            <p:nvPr/>
          </p:nvCxnSpPr>
          <p:spPr>
            <a:xfrm>
              <a:off x="3905215" y="3039202"/>
              <a:ext cx="0" cy="31513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DD099FD1-F49A-4DAF-85B8-4F5FACD4B32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94373" y="3940953"/>
              <a:ext cx="41969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D39E4330-4F93-4F08-BB79-940FE1CA7268}"/>
                </a:ext>
              </a:extLst>
            </p:cNvPr>
            <p:cNvCxnSpPr/>
            <p:nvPr/>
          </p:nvCxnSpPr>
          <p:spPr>
            <a:xfrm>
              <a:off x="1181441" y="2975610"/>
              <a:ext cx="7239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97BCF42C-A8B0-44D5-9109-E3476343354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7750" y="2137410"/>
              <a:ext cx="0" cy="71628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2776469-60D9-408C-AC8A-35F5DE45C06F}"/>
                </a:ext>
              </a:extLst>
            </p:cNvPr>
            <p:cNvSpPr txBox="1"/>
            <p:nvPr/>
          </p:nvSpPr>
          <p:spPr>
            <a:xfrm>
              <a:off x="1364321" y="2945131"/>
              <a:ext cx="377190" cy="3662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4EDBDAD-917C-4B49-AC5D-8390AF3ECAED}"/>
                </a:ext>
              </a:extLst>
            </p:cNvPr>
            <p:cNvSpPr txBox="1"/>
            <p:nvPr/>
          </p:nvSpPr>
          <p:spPr>
            <a:xfrm rot="16200000">
              <a:off x="769576" y="2329233"/>
              <a:ext cx="418477" cy="2892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6DAD10BC-E159-4128-9868-52F0374FD06A}"/>
                </a:ext>
              </a:extLst>
            </p:cNvPr>
            <p:cNvCxnSpPr/>
            <p:nvPr/>
          </p:nvCxnSpPr>
          <p:spPr>
            <a:xfrm>
              <a:off x="2434303" y="2975610"/>
              <a:ext cx="7239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70DC310F-CF8E-426E-A68D-ECF4CB537B7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77637" y="2137410"/>
              <a:ext cx="0" cy="71628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79686E9-6862-485A-9365-36C2C834915F}"/>
                </a:ext>
              </a:extLst>
            </p:cNvPr>
            <p:cNvSpPr txBox="1"/>
            <p:nvPr/>
          </p:nvSpPr>
          <p:spPr>
            <a:xfrm>
              <a:off x="2617183" y="2954321"/>
              <a:ext cx="377190" cy="3662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3634551-FF2D-45F9-B5D3-46669BFE5BBC}"/>
                </a:ext>
              </a:extLst>
            </p:cNvPr>
            <p:cNvSpPr txBox="1"/>
            <p:nvPr/>
          </p:nvSpPr>
          <p:spPr>
            <a:xfrm rot="16200000">
              <a:off x="1999463" y="2329233"/>
              <a:ext cx="418477" cy="2892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49462BA6-B6FC-4229-AE13-F751208DECA5}"/>
                </a:ext>
              </a:extLst>
            </p:cNvPr>
            <p:cNvCxnSpPr/>
            <p:nvPr/>
          </p:nvCxnSpPr>
          <p:spPr>
            <a:xfrm>
              <a:off x="3741385" y="3000524"/>
              <a:ext cx="7239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D4077808-D3ED-4106-95F4-073E886302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03099" y="2139349"/>
              <a:ext cx="0" cy="71628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A4BFCDD-7A95-4B76-BA0F-2F17CD732BA6}"/>
                </a:ext>
              </a:extLst>
            </p:cNvPr>
            <p:cNvSpPr txBox="1"/>
            <p:nvPr/>
          </p:nvSpPr>
          <p:spPr>
            <a:xfrm>
              <a:off x="3905215" y="2975610"/>
              <a:ext cx="560070" cy="2892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Zombie NIR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A5D238A-99F5-4B70-97B9-BA6E360F7519}"/>
                </a:ext>
              </a:extLst>
            </p:cNvPr>
            <p:cNvSpPr txBox="1"/>
            <p:nvPr/>
          </p:nvSpPr>
          <p:spPr>
            <a:xfrm rot="16200000">
              <a:off x="3324924" y="2331171"/>
              <a:ext cx="418477" cy="2892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B9DF91E2-2E88-4314-987B-3A9C04F3AE30}"/>
                </a:ext>
              </a:extLst>
            </p:cNvPr>
            <p:cNvCxnSpPr/>
            <p:nvPr/>
          </p:nvCxnSpPr>
          <p:spPr>
            <a:xfrm>
              <a:off x="3741385" y="4376242"/>
              <a:ext cx="7239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073D3936-C261-434F-B680-BFA50F3517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03099" y="3515067"/>
              <a:ext cx="0" cy="71628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C49DEF5-0A7D-4596-8FB8-355B740FD96C}"/>
                </a:ext>
              </a:extLst>
            </p:cNvPr>
            <p:cNvSpPr txBox="1"/>
            <p:nvPr/>
          </p:nvSpPr>
          <p:spPr>
            <a:xfrm>
              <a:off x="3905215" y="4351327"/>
              <a:ext cx="560070" cy="212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EA1A9AB-02C0-4548-9723-674747AE3171}"/>
                </a:ext>
              </a:extLst>
            </p:cNvPr>
            <p:cNvSpPr txBox="1"/>
            <p:nvPr/>
          </p:nvSpPr>
          <p:spPr>
            <a:xfrm rot="16200000">
              <a:off x="3324924" y="3706889"/>
              <a:ext cx="418475" cy="2892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7B1BDF34-0EB1-4B42-8F9A-4F6431A7A308}"/>
                </a:ext>
              </a:extLst>
            </p:cNvPr>
            <p:cNvCxnSpPr/>
            <p:nvPr/>
          </p:nvCxnSpPr>
          <p:spPr>
            <a:xfrm>
              <a:off x="2092506" y="4409126"/>
              <a:ext cx="7239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A63625AB-C039-4DBD-A2B5-D23E73157ED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54220" y="3547951"/>
              <a:ext cx="0" cy="71628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16AFEB4-D10F-4300-BD8E-B9B822884E85}"/>
                </a:ext>
              </a:extLst>
            </p:cNvPr>
            <p:cNvSpPr txBox="1"/>
            <p:nvPr/>
          </p:nvSpPr>
          <p:spPr>
            <a:xfrm>
              <a:off x="2256336" y="4384212"/>
              <a:ext cx="560070" cy="212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E771975-85EA-4D37-8794-553D264CC899}"/>
                </a:ext>
              </a:extLst>
            </p:cNvPr>
            <p:cNvSpPr txBox="1"/>
            <p:nvPr/>
          </p:nvSpPr>
          <p:spPr>
            <a:xfrm rot="16200000">
              <a:off x="1676046" y="3778236"/>
              <a:ext cx="418477" cy="212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4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46079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y Chen</dc:creator>
  <cp:lastModifiedBy>Amy Chen</cp:lastModifiedBy>
  <cp:revision>1</cp:revision>
  <dcterms:created xsi:type="dcterms:W3CDTF">2025-10-25T06:02:41Z</dcterms:created>
  <dcterms:modified xsi:type="dcterms:W3CDTF">2025-10-25T06:03:21Z</dcterms:modified>
</cp:coreProperties>
</file>